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1D3DCD-01A0-4646-8D77-0D4D41C46C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2722C-3853-45DA-BA76-793B0FDBA9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4C1C96-A868-4B3F-8F77-3E539F1049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2983E-258C-4599-982D-435A8D3849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FAF09-EA6B-4C14-BD3C-323D480440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A41D4-6CA7-4BD9-BED1-5472BA2864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41A5D-4901-4EA6-B123-66ADDC7299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9D1D3-0800-4667-8009-2AC32E4A72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169AE-A8CD-433A-A723-6607312A27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FEE4B5-37EB-40D9-BDDF-00D1092073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4E53C-8B43-4E59-BE54-2E7474AF3E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08D9C-5F97-45EC-BBA3-010F4A5D07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Meiryo U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Meiryo U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Meiryo U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Meiryo U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Meiryo U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C42D2B-7C8E-4B05-8D6F-EB18BCBC659C}" type="slidenum">
              <a:rPr b="0" lang="ja-JP" sz="1200" spc="-1" strike="noStrike">
                <a:solidFill>
                  <a:srgbClr val="898989"/>
                </a:solidFill>
                <a:latin typeface="Meiryo U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Meiryo U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11" descr=""/>
          <p:cNvPicPr/>
          <p:nvPr/>
        </p:nvPicPr>
        <p:blipFill>
          <a:blip r:embed="rId1"/>
          <a:stretch/>
        </p:blipFill>
        <p:spPr>
          <a:xfrm>
            <a:off x="1979640" y="468360"/>
            <a:ext cx="5699160" cy="3994200"/>
          </a:xfrm>
          <a:prstGeom prst="rect">
            <a:avLst/>
          </a:prstGeom>
          <a:ln w="0">
            <a:noFill/>
          </a:ln>
        </p:spPr>
      </p:pic>
      <p:sp>
        <p:nvSpPr>
          <p:cNvPr id="42" name="下矢印 3"/>
          <p:cNvSpPr/>
          <p:nvPr/>
        </p:nvSpPr>
        <p:spPr>
          <a:xfrm>
            <a:off x="4276800" y="1000080"/>
            <a:ext cx="181080" cy="387360"/>
          </a:xfrm>
          <a:prstGeom prst="downArrow">
            <a:avLst>
              <a:gd name="adj1" fmla="val 50000"/>
              <a:gd name="adj2" fmla="val 49666"/>
            </a:avLst>
          </a:prstGeom>
          <a:solidFill>
            <a:srgbClr val="0000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3" name="下矢印 4"/>
          <p:cNvSpPr/>
          <p:nvPr/>
        </p:nvSpPr>
        <p:spPr>
          <a:xfrm>
            <a:off x="4530600" y="2035080"/>
            <a:ext cx="73080" cy="468360"/>
          </a:xfrm>
          <a:prstGeom prst="downArrow">
            <a:avLst>
              <a:gd name="adj1" fmla="val 50000"/>
              <a:gd name="adj2" fmla="val 64682"/>
            </a:avLst>
          </a:prstGeom>
          <a:solidFill>
            <a:srgbClr val="0000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4" name="上矢印 14"/>
          <p:cNvSpPr/>
          <p:nvPr/>
        </p:nvSpPr>
        <p:spPr>
          <a:xfrm>
            <a:off x="4802040" y="1843200"/>
            <a:ext cx="108000" cy="750600"/>
          </a:xfrm>
          <a:prstGeom prst="upArrow">
            <a:avLst>
              <a:gd name="adj1" fmla="val 50000"/>
              <a:gd name="adj2" fmla="val 0"/>
            </a:avLst>
          </a:prstGeom>
          <a:solidFill>
            <a:srgbClr val="0000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45" name="右矢印 15"/>
          <p:cNvSpPr/>
          <p:nvPr/>
        </p:nvSpPr>
        <p:spPr>
          <a:xfrm>
            <a:off x="4881600" y="1808280"/>
            <a:ext cx="2098800" cy="108000"/>
          </a:xfrm>
          <a:prstGeom prst="rightArrow">
            <a:avLst>
              <a:gd name="adj1" fmla="val 39537"/>
              <a:gd name="adj2" fmla="val 50023"/>
            </a:avLst>
          </a:prstGeom>
          <a:solidFill>
            <a:srgbClr val="0000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grpSp>
        <p:nvGrpSpPr>
          <p:cNvPr id="46" name="グループ化 17"/>
          <p:cNvGrpSpPr/>
          <p:nvPr/>
        </p:nvGrpSpPr>
        <p:grpSpPr>
          <a:xfrm>
            <a:off x="4609440" y="1671480"/>
            <a:ext cx="1975680" cy="547920"/>
            <a:chOff x="4609440" y="1671480"/>
            <a:chExt cx="1975680" cy="547920"/>
          </a:xfrm>
        </p:grpSpPr>
        <p:sp>
          <p:nvSpPr>
            <p:cNvPr id="47" name="直線コネクタ 18"/>
            <p:cNvSpPr/>
            <p:nvPr/>
          </p:nvSpPr>
          <p:spPr>
            <a:xfrm flipV="1">
              <a:off x="6585120" y="1671480"/>
              <a:ext cx="0" cy="547920"/>
            </a:xfrm>
            <a:prstGeom prst="line">
              <a:avLst/>
            </a:prstGeom>
            <a:ln w="19080">
              <a:solidFill>
                <a:srgbClr val="4a7ebb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48" name="直線コネクタ 19"/>
            <p:cNvSpPr/>
            <p:nvPr/>
          </p:nvSpPr>
          <p:spPr>
            <a:xfrm flipH="1">
              <a:off x="4765680" y="1671480"/>
              <a:ext cx="1819080" cy="0"/>
            </a:xfrm>
            <a:prstGeom prst="line">
              <a:avLst/>
            </a:prstGeom>
            <a:ln w="19080">
              <a:solidFill>
                <a:srgbClr val="4a7ebb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cxnSp>
          <p:nvCxnSpPr>
            <p:cNvPr id="49" name="直線矢印コネクタ 20"/>
            <p:cNvCxnSpPr/>
            <p:nvPr/>
          </p:nvCxnSpPr>
          <p:spPr>
            <a:xfrm flipH="1">
              <a:off x="4609440" y="1673280"/>
              <a:ext cx="218520" cy="1080"/>
            </a:xfrm>
            <a:prstGeom prst="straightConnector1">
              <a:avLst/>
            </a:prstGeom>
            <a:ln w="19080">
              <a:solidFill>
                <a:srgbClr val="4a7ebb"/>
              </a:solidFill>
              <a:miter/>
              <a:tailEnd len="lg" type="triangle" w="lg"/>
            </a:ln>
          </p:spPr>
        </p:cxnSp>
      </p:grpSp>
      <p:sp>
        <p:nvSpPr>
          <p:cNvPr id="50" name="テキスト ボックス 26"/>
          <p:cNvSpPr/>
          <p:nvPr/>
        </p:nvSpPr>
        <p:spPr>
          <a:xfrm>
            <a:off x="3776760" y="169920"/>
            <a:ext cx="1511280" cy="459000"/>
          </a:xfrm>
          <a:prstGeom prst="rect">
            <a:avLst/>
          </a:prstGeom>
          <a:solidFill>
            <a:srgbClr val="ffffff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entury Gothic"/>
                <a:ea typeface="ＭＳ Ｐゴシック"/>
              </a:rPr>
              <a:t>Aerosol generator</a:t>
            </a:r>
            <a:endParaRPr b="0" lang="en-US" sz="1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51" name="テキスト ボックス 27"/>
          <p:cNvSpPr/>
          <p:nvPr/>
        </p:nvSpPr>
        <p:spPr>
          <a:xfrm>
            <a:off x="6014880" y="177120"/>
            <a:ext cx="1751040" cy="459000"/>
          </a:xfrm>
          <a:prstGeom prst="rect">
            <a:avLst/>
          </a:prstGeom>
          <a:solidFill>
            <a:srgbClr val="ffffff"/>
          </a:solidFill>
          <a:ln w="1584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entury Gothic"/>
                <a:ea typeface="Times New Roman"/>
              </a:rPr>
              <a:t>Inhalation</a:t>
            </a:r>
            <a:r>
              <a:rPr b="1" lang="ja-JP" sz="1200" spc="-1" strike="noStrike">
                <a:solidFill>
                  <a:srgbClr val="000000"/>
                </a:solidFill>
                <a:latin typeface="Century Gothic"/>
                <a:ea typeface="Times New Roman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Century Gothic"/>
                <a:ea typeface="Times New Roman"/>
              </a:rPr>
              <a:t>chamber</a:t>
            </a:r>
            <a:endParaRPr b="0" lang="en-US" sz="12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52" name="テキスト ボックス 28"/>
          <p:cNvSpPr/>
          <p:nvPr/>
        </p:nvSpPr>
        <p:spPr>
          <a:xfrm>
            <a:off x="6278400" y="2686680"/>
            <a:ext cx="61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entury Gothic"/>
                <a:ea typeface="メイリオ"/>
              </a:rPr>
              <a:t>OPC</a:t>
            </a:r>
            <a:endParaRPr b="0" lang="en-US" sz="1200" spc="-1" strike="noStrike">
              <a:solidFill>
                <a:srgbClr val="000000"/>
              </a:solidFill>
              <a:latin typeface="Meiryo UI"/>
            </a:endParaRPr>
          </a:p>
        </p:txBody>
      </p:sp>
      <p:grpSp>
        <p:nvGrpSpPr>
          <p:cNvPr id="53" name="暴露チャンバー微粉"/>
          <p:cNvGrpSpPr/>
          <p:nvPr/>
        </p:nvGrpSpPr>
        <p:grpSpPr>
          <a:xfrm>
            <a:off x="7104240" y="2252520"/>
            <a:ext cx="274320" cy="185760"/>
            <a:chOff x="7104240" y="2252520"/>
            <a:chExt cx="274320" cy="185760"/>
          </a:xfrm>
        </p:grpSpPr>
        <p:sp>
          <p:nvSpPr>
            <p:cNvPr id="54" name="円/楕円 1"/>
            <p:cNvSpPr/>
            <p:nvPr/>
          </p:nvSpPr>
          <p:spPr>
            <a:xfrm>
              <a:off x="7157160" y="2282040"/>
              <a:ext cx="540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55" name="円/楕円 33"/>
            <p:cNvSpPr/>
            <p:nvPr/>
          </p:nvSpPr>
          <p:spPr>
            <a:xfrm>
              <a:off x="7213680" y="225252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56" name="円/楕円 34"/>
            <p:cNvSpPr/>
            <p:nvPr/>
          </p:nvSpPr>
          <p:spPr>
            <a:xfrm>
              <a:off x="7257240" y="2267640"/>
              <a:ext cx="612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57" name="円/楕円 35"/>
            <p:cNvSpPr/>
            <p:nvPr/>
          </p:nvSpPr>
          <p:spPr>
            <a:xfrm>
              <a:off x="7319160" y="2256840"/>
              <a:ext cx="612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58" name="円/楕円 36"/>
            <p:cNvSpPr/>
            <p:nvPr/>
          </p:nvSpPr>
          <p:spPr>
            <a:xfrm>
              <a:off x="7355880" y="233604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59" name="円/楕円 37"/>
            <p:cNvSpPr/>
            <p:nvPr/>
          </p:nvSpPr>
          <p:spPr>
            <a:xfrm>
              <a:off x="7111800" y="2322720"/>
              <a:ext cx="540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0" name="円/楕円 38"/>
            <p:cNvSpPr/>
            <p:nvPr/>
          </p:nvSpPr>
          <p:spPr>
            <a:xfrm>
              <a:off x="7261920" y="238212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1" name="円/楕円 39"/>
            <p:cNvSpPr/>
            <p:nvPr/>
          </p:nvSpPr>
          <p:spPr>
            <a:xfrm>
              <a:off x="7162920" y="237024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2" name="円/楕円 40"/>
            <p:cNvSpPr/>
            <p:nvPr/>
          </p:nvSpPr>
          <p:spPr>
            <a:xfrm>
              <a:off x="7329240" y="241632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3" name="円/楕円 41"/>
            <p:cNvSpPr/>
            <p:nvPr/>
          </p:nvSpPr>
          <p:spPr>
            <a:xfrm>
              <a:off x="7307280" y="2375640"/>
              <a:ext cx="612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4" name="円/楕円 42"/>
            <p:cNvSpPr/>
            <p:nvPr/>
          </p:nvSpPr>
          <p:spPr>
            <a:xfrm>
              <a:off x="7193880" y="2413080"/>
              <a:ext cx="540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5" name="円/楕円 43"/>
            <p:cNvSpPr/>
            <p:nvPr/>
          </p:nvSpPr>
          <p:spPr>
            <a:xfrm>
              <a:off x="7117560" y="2426400"/>
              <a:ext cx="612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6" name="円/楕円 44"/>
            <p:cNvSpPr/>
            <p:nvPr/>
          </p:nvSpPr>
          <p:spPr>
            <a:xfrm>
              <a:off x="7212960" y="2318400"/>
              <a:ext cx="612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7" name="円/楕円 45"/>
            <p:cNvSpPr/>
            <p:nvPr/>
          </p:nvSpPr>
          <p:spPr>
            <a:xfrm>
              <a:off x="7104240" y="2256840"/>
              <a:ext cx="540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8" name="円/楕円 46"/>
            <p:cNvSpPr/>
            <p:nvPr/>
          </p:nvSpPr>
          <p:spPr>
            <a:xfrm>
              <a:off x="7369200" y="2269800"/>
              <a:ext cx="612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69" name="円/楕円 47"/>
            <p:cNvSpPr/>
            <p:nvPr/>
          </p:nvSpPr>
          <p:spPr>
            <a:xfrm>
              <a:off x="7373160" y="2413080"/>
              <a:ext cx="5400" cy="129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</p:grpSp>
      <p:sp>
        <p:nvSpPr>
          <p:cNvPr id="70" name="左カーブ矢印 113"/>
          <p:cNvSpPr/>
          <p:nvPr/>
        </p:nvSpPr>
        <p:spPr>
          <a:xfrm flipH="1" flipV="1">
            <a:off x="2685960" y="2099520"/>
            <a:ext cx="216000" cy="119160"/>
          </a:xfrm>
          <a:custGeom>
            <a:avLst/>
            <a:gdLst>
              <a:gd name="textAreaLeft" fmla="*/ 28800 w 216000"/>
              <a:gd name="textAreaRight" fmla="*/ 187200 w 216000"/>
              <a:gd name="textAreaTop" fmla="*/ 18360 h 119160"/>
              <a:gd name="textAreaBottom" fmla="*/ 85680 h 1191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5400000"/>
                <a:lnTo>
                  <a:pt x="0" y="21600"/>
                </a:lnTo>
                <a:lnTo>
                  <a:pt x="0" y="16200"/>
                </a:lnTo>
                <a:lnTo>
                  <a:pt x="0" y="10800"/>
                </a:lnTo>
                <a:lnTo>
                  <a:pt x="0" y="13500"/>
                </a:lnTo>
                <a:arcTo wR="21600" hR="6750" stAng="5400000" swAng="-4934014"/>
                <a:lnTo>
                  <a:pt x="19797" y="9450"/>
                </a:lnTo>
                <a:arcTo wR="21600" hR="6750" stAng="-465986" swAng="-4934014"/>
                <a:close/>
              </a:path>
              <a:path fill="darkenLess"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-465986"/>
                <a:lnTo>
                  <a:pt x="19797" y="9450"/>
                </a:lnTo>
                <a:arcTo wR="21600" hR="6750" stAng="-465986" swAng="-4934014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1" name="左カーブ矢印 112"/>
          <p:cNvSpPr/>
          <p:nvPr/>
        </p:nvSpPr>
        <p:spPr>
          <a:xfrm flipV="1">
            <a:off x="2897280" y="1979640"/>
            <a:ext cx="215640" cy="239760"/>
          </a:xfrm>
          <a:custGeom>
            <a:avLst/>
            <a:gdLst>
              <a:gd name="textAreaLeft" fmla="*/ 28800 w 215640"/>
              <a:gd name="textAreaRight" fmla="*/ 186840 w 215640"/>
              <a:gd name="textAreaTop" fmla="*/ 47520 h 239760"/>
              <a:gd name="textAreaBottom" fmla="*/ 171000 h 2397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8531" stAng="-5400000" swAng="5400000"/>
                <a:lnTo>
                  <a:pt x="21600" y="11112"/>
                </a:lnTo>
                <a:arcTo wR="21600" hR="8531" stAng="0" swAng="5400000"/>
                <a:lnTo>
                  <a:pt x="0" y="21600"/>
                </a:lnTo>
                <a:lnTo>
                  <a:pt x="0" y="18352"/>
                </a:lnTo>
                <a:lnTo>
                  <a:pt x="0" y="15103"/>
                </a:lnTo>
                <a:lnTo>
                  <a:pt x="0" y="17061"/>
                </a:lnTo>
                <a:arcTo wR="21600" hR="8531" stAng="5400000" swAng="-5192472"/>
                <a:lnTo>
                  <a:pt x="21351" y="9821"/>
                </a:lnTo>
                <a:arcTo wR="21600" hR="8531" stAng="-207528" swAng="-5192472"/>
                <a:close/>
              </a:path>
              <a:path fill="darkenLess" w="21600" h="21600">
                <a:moveTo>
                  <a:pt x="0" y="0"/>
                </a:moveTo>
                <a:arcTo wR="21600" hR="8531" stAng="-5400000" swAng="5400000"/>
                <a:lnTo>
                  <a:pt x="21600" y="11112"/>
                </a:lnTo>
                <a:arcTo wR="21600" hR="8531" stAng="0" swAng="-207528"/>
                <a:lnTo>
                  <a:pt x="21351" y="9821"/>
                </a:lnTo>
                <a:arcTo wR="21600" hR="8531" stAng="-207528" swAng="-5192472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2" name="左カーブ矢印 115"/>
          <p:cNvSpPr/>
          <p:nvPr/>
        </p:nvSpPr>
        <p:spPr>
          <a:xfrm flipH="1" flipV="1">
            <a:off x="2685960" y="1979640"/>
            <a:ext cx="216000" cy="138240"/>
          </a:xfrm>
          <a:custGeom>
            <a:avLst/>
            <a:gdLst>
              <a:gd name="textAreaLeft" fmla="*/ 28800 w 216000"/>
              <a:gd name="textAreaRight" fmla="*/ 187200 w 216000"/>
              <a:gd name="textAreaTop" fmla="*/ 21600 h 138240"/>
              <a:gd name="textAreaBottom" fmla="*/ 99360 h 138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5400000"/>
                <a:lnTo>
                  <a:pt x="0" y="21600"/>
                </a:lnTo>
                <a:lnTo>
                  <a:pt x="0" y="16200"/>
                </a:lnTo>
                <a:lnTo>
                  <a:pt x="0" y="10800"/>
                </a:lnTo>
                <a:lnTo>
                  <a:pt x="0" y="13500"/>
                </a:lnTo>
                <a:arcTo wR="21600" hR="6750" stAng="5400000" swAng="-4934014"/>
                <a:lnTo>
                  <a:pt x="19797" y="9450"/>
                </a:lnTo>
                <a:arcTo wR="21600" hR="6750" stAng="-465986" swAng="-4934014"/>
                <a:close/>
              </a:path>
              <a:path fill="darkenLess"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-465986"/>
                <a:lnTo>
                  <a:pt x="19797" y="9450"/>
                </a:lnTo>
                <a:arcTo wR="21600" hR="6750" stAng="-465986" swAng="-4934014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3" name="左カーブ矢印 114"/>
          <p:cNvSpPr/>
          <p:nvPr/>
        </p:nvSpPr>
        <p:spPr>
          <a:xfrm flipV="1">
            <a:off x="2897280" y="1879560"/>
            <a:ext cx="215640" cy="238320"/>
          </a:xfrm>
          <a:custGeom>
            <a:avLst/>
            <a:gdLst>
              <a:gd name="textAreaLeft" fmla="*/ 28800 w 215640"/>
              <a:gd name="textAreaRight" fmla="*/ 186840 w 215640"/>
              <a:gd name="textAreaTop" fmla="*/ 46800 h 238320"/>
              <a:gd name="textAreaBottom" fmla="*/ 174240 h 238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8522" stAng="-5400000" swAng="5400000"/>
                <a:lnTo>
                  <a:pt x="21600" y="11534"/>
                </a:lnTo>
                <a:arcTo wR="21600" hR="8522" stAng="0" swAng="5400000"/>
                <a:lnTo>
                  <a:pt x="0" y="21600"/>
                </a:lnTo>
                <a:lnTo>
                  <a:pt x="0" y="18549"/>
                </a:lnTo>
                <a:lnTo>
                  <a:pt x="0" y="15498"/>
                </a:lnTo>
                <a:lnTo>
                  <a:pt x="0" y="17043"/>
                </a:lnTo>
                <a:arcTo wR="21600" hR="8522" stAng="5400000" swAng="-5156886"/>
                <a:lnTo>
                  <a:pt x="21260" y="10028"/>
                </a:lnTo>
                <a:arcTo wR="21600" hR="8522" stAng="-243114" swAng="-5156886"/>
                <a:close/>
              </a:path>
              <a:path fill="darkenLess" w="21600" h="21600">
                <a:moveTo>
                  <a:pt x="0" y="0"/>
                </a:moveTo>
                <a:arcTo wR="21600" hR="8522" stAng="-5400000" swAng="5400000"/>
                <a:lnTo>
                  <a:pt x="21600" y="11534"/>
                </a:lnTo>
                <a:arcTo wR="21600" hR="8522" stAng="0" swAng="-243114"/>
                <a:lnTo>
                  <a:pt x="21260" y="10028"/>
                </a:lnTo>
                <a:arcTo wR="21600" hR="8522" stAng="-243114" swAng="-5156886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4" name="左カーブ矢印 117"/>
          <p:cNvSpPr/>
          <p:nvPr/>
        </p:nvSpPr>
        <p:spPr>
          <a:xfrm flipH="1" flipV="1">
            <a:off x="2685960" y="1879560"/>
            <a:ext cx="216000" cy="138240"/>
          </a:xfrm>
          <a:custGeom>
            <a:avLst/>
            <a:gdLst>
              <a:gd name="textAreaLeft" fmla="*/ 28800 w 216000"/>
              <a:gd name="textAreaRight" fmla="*/ 187200 w 216000"/>
              <a:gd name="textAreaTop" fmla="*/ 21600 h 138240"/>
              <a:gd name="textAreaBottom" fmla="*/ 99360 h 138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5400000"/>
                <a:lnTo>
                  <a:pt x="0" y="21600"/>
                </a:lnTo>
                <a:lnTo>
                  <a:pt x="0" y="16200"/>
                </a:lnTo>
                <a:lnTo>
                  <a:pt x="0" y="10800"/>
                </a:lnTo>
                <a:lnTo>
                  <a:pt x="0" y="13500"/>
                </a:lnTo>
                <a:arcTo wR="21600" hR="6750" stAng="5400000" swAng="-4934014"/>
                <a:lnTo>
                  <a:pt x="19797" y="9450"/>
                </a:lnTo>
                <a:arcTo wR="21600" hR="6750" stAng="-465986" swAng="-4934014"/>
                <a:close/>
              </a:path>
              <a:path fill="darkenLess"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-465986"/>
                <a:lnTo>
                  <a:pt x="19797" y="9450"/>
                </a:lnTo>
                <a:arcTo wR="21600" hR="6750" stAng="-465986" swAng="-4934014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5" name="左カーブ矢印 116"/>
          <p:cNvSpPr/>
          <p:nvPr/>
        </p:nvSpPr>
        <p:spPr>
          <a:xfrm flipV="1">
            <a:off x="2898720" y="1777320"/>
            <a:ext cx="216000" cy="237960"/>
          </a:xfrm>
          <a:custGeom>
            <a:avLst/>
            <a:gdLst>
              <a:gd name="textAreaLeft" fmla="*/ 28800 w 216000"/>
              <a:gd name="textAreaRight" fmla="*/ 187200 w 216000"/>
              <a:gd name="textAreaTop" fmla="*/ 47520 h 237960"/>
              <a:gd name="textAreaBottom" fmla="*/ 176040 h 237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8629" stAng="-5400000" swAng="5400000"/>
                <a:lnTo>
                  <a:pt x="21600" y="11641"/>
                </a:lnTo>
                <a:arcTo wR="21600" hR="8629" stAng="0" swAng="5400000"/>
                <a:lnTo>
                  <a:pt x="0" y="21600"/>
                </a:lnTo>
                <a:lnTo>
                  <a:pt x="0" y="18764"/>
                </a:lnTo>
                <a:lnTo>
                  <a:pt x="0" y="15928"/>
                </a:lnTo>
                <a:lnTo>
                  <a:pt x="0" y="17258"/>
                </a:lnTo>
                <a:arcTo wR="21600" hR="8629" stAng="5400000" swAng="-5156982"/>
                <a:lnTo>
                  <a:pt x="21268" y="10135"/>
                </a:lnTo>
                <a:arcTo wR="21600" hR="8629" stAng="-243018" swAng="-5156982"/>
                <a:close/>
              </a:path>
              <a:path fill="darkenLess" w="21600" h="21600">
                <a:moveTo>
                  <a:pt x="0" y="0"/>
                </a:moveTo>
                <a:arcTo wR="21600" hR="8629" stAng="-5400000" swAng="5400000"/>
                <a:lnTo>
                  <a:pt x="21600" y="11641"/>
                </a:lnTo>
                <a:arcTo wR="21600" hR="8629" stAng="0" swAng="-243018"/>
                <a:lnTo>
                  <a:pt x="21268" y="10135"/>
                </a:lnTo>
                <a:arcTo wR="21600" hR="8629" stAng="-243018" swAng="-5156982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6" name="左カーブ矢印 78"/>
          <p:cNvSpPr/>
          <p:nvPr/>
        </p:nvSpPr>
        <p:spPr>
          <a:xfrm flipH="1" flipV="1">
            <a:off x="2685960" y="1772640"/>
            <a:ext cx="216000" cy="144360"/>
          </a:xfrm>
          <a:custGeom>
            <a:avLst/>
            <a:gdLst>
              <a:gd name="textAreaLeft" fmla="*/ 28800 w 216000"/>
              <a:gd name="textAreaRight" fmla="*/ 187200 w 216000"/>
              <a:gd name="textAreaTop" fmla="*/ 21960 h 144360"/>
              <a:gd name="textAreaBottom" fmla="*/ 103320 h 144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5400000"/>
                <a:lnTo>
                  <a:pt x="0" y="21600"/>
                </a:lnTo>
                <a:lnTo>
                  <a:pt x="0" y="16200"/>
                </a:lnTo>
                <a:lnTo>
                  <a:pt x="0" y="10800"/>
                </a:lnTo>
                <a:lnTo>
                  <a:pt x="0" y="13500"/>
                </a:lnTo>
                <a:arcTo wR="21600" hR="6750" stAng="5400000" swAng="-4934014"/>
                <a:lnTo>
                  <a:pt x="19797" y="9450"/>
                </a:lnTo>
                <a:arcTo wR="21600" hR="6750" stAng="-465986" swAng="-4934014"/>
                <a:close/>
              </a:path>
              <a:path fill="darkenLess"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-465986"/>
                <a:lnTo>
                  <a:pt x="19797" y="9450"/>
                </a:lnTo>
                <a:arcTo wR="21600" hR="6750" stAng="-465986" swAng="-4934014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77" name="左カーブ矢印 77"/>
          <p:cNvSpPr/>
          <p:nvPr/>
        </p:nvSpPr>
        <p:spPr>
          <a:xfrm flipV="1">
            <a:off x="2898720" y="1688400"/>
            <a:ext cx="216000" cy="228600"/>
          </a:xfrm>
          <a:custGeom>
            <a:avLst/>
            <a:gdLst>
              <a:gd name="textAreaLeft" fmla="*/ 28800 w 216000"/>
              <a:gd name="textAreaRight" fmla="*/ 187200 w 216000"/>
              <a:gd name="textAreaTop" fmla="*/ 38880 h 228600"/>
              <a:gd name="textAreaBottom" fmla="*/ 155160 h 228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7337" stAng="-5400000" swAng="5400000"/>
                <a:lnTo>
                  <a:pt x="21600" y="10970"/>
                </a:lnTo>
                <a:arcTo wR="21600" hR="7337" stAng="0" swAng="3713122"/>
                <a:lnTo>
                  <a:pt x="3857" y="21482"/>
                </a:lnTo>
                <a:lnTo>
                  <a:pt x="0" y="16491"/>
                </a:lnTo>
                <a:lnTo>
                  <a:pt x="3857" y="11263"/>
                </a:lnTo>
                <a:lnTo>
                  <a:pt x="3857" y="14556"/>
                </a:lnTo>
                <a:arcTo wR="21600" hR="7337" stAng="3713122" swAng="-3415473"/>
                <a:lnTo>
                  <a:pt x="20928" y="9154"/>
                </a:lnTo>
                <a:arcTo wR="21600" hR="7337" stAng="-297649" swAng="-5102351"/>
                <a:close/>
              </a:path>
              <a:path fill="darkenLess" w="21600" h="21600">
                <a:moveTo>
                  <a:pt x="0" y="0"/>
                </a:moveTo>
                <a:arcTo wR="21600" hR="7337" stAng="-5400000" swAng="5400000"/>
                <a:lnTo>
                  <a:pt x="21600" y="10970"/>
                </a:lnTo>
                <a:arcTo wR="21600" hR="7337" stAng="0" swAng="-297649"/>
                <a:lnTo>
                  <a:pt x="20928" y="9154"/>
                </a:lnTo>
                <a:arcTo wR="21600" hR="7337" stAng="-297649" swAng="-5102351"/>
                <a:close/>
              </a:path>
            </a:pathLst>
          </a:cu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grpSp>
        <p:nvGrpSpPr>
          <p:cNvPr id="78" name="グループ化 9"/>
          <p:cNvGrpSpPr/>
          <p:nvPr/>
        </p:nvGrpSpPr>
        <p:grpSpPr>
          <a:xfrm>
            <a:off x="2695680" y="1422360"/>
            <a:ext cx="431640" cy="100080"/>
            <a:chOff x="2695680" y="1422360"/>
            <a:chExt cx="431640" cy="100080"/>
          </a:xfrm>
        </p:grpSpPr>
        <p:sp>
          <p:nvSpPr>
            <p:cNvPr id="79" name="上矢印 82"/>
            <p:cNvSpPr/>
            <p:nvPr/>
          </p:nvSpPr>
          <p:spPr>
            <a:xfrm>
              <a:off x="2695680" y="1422360"/>
              <a:ext cx="115200" cy="100080"/>
            </a:xfrm>
            <a:prstGeom prst="upArrow">
              <a:avLst>
                <a:gd name="adj1" fmla="val 50000"/>
                <a:gd name="adj2" fmla="val 50000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80" name="上矢印 83"/>
            <p:cNvSpPr/>
            <p:nvPr/>
          </p:nvSpPr>
          <p:spPr>
            <a:xfrm>
              <a:off x="2865600" y="1422360"/>
              <a:ext cx="115200" cy="100080"/>
            </a:xfrm>
            <a:prstGeom prst="upArrow">
              <a:avLst>
                <a:gd name="adj1" fmla="val 50000"/>
                <a:gd name="adj2" fmla="val 50000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81" name="上矢印 84"/>
            <p:cNvSpPr/>
            <p:nvPr/>
          </p:nvSpPr>
          <p:spPr>
            <a:xfrm>
              <a:off x="3012120" y="1422360"/>
              <a:ext cx="115200" cy="100080"/>
            </a:xfrm>
            <a:prstGeom prst="upArrow">
              <a:avLst>
                <a:gd name="adj1" fmla="val 50000"/>
                <a:gd name="adj2" fmla="val 50000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</p:grpSp>
      <p:sp>
        <p:nvSpPr>
          <p:cNvPr id="82" name="上矢印 85"/>
          <p:cNvSpPr/>
          <p:nvPr/>
        </p:nvSpPr>
        <p:spPr>
          <a:xfrm>
            <a:off x="2840040" y="973080"/>
            <a:ext cx="108000" cy="149400"/>
          </a:xfrm>
          <a:prstGeom prst="upArrow">
            <a:avLst>
              <a:gd name="adj1" fmla="val 50000"/>
              <a:gd name="adj2" fmla="val 49966"/>
            </a:avLst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83" name="小サイクロン右"/>
          <p:cNvSpPr/>
          <p:nvPr/>
        </p:nvSpPr>
        <p:spPr>
          <a:xfrm flipV="1">
            <a:off x="4843440" y="2853720"/>
            <a:ext cx="100080" cy="120600"/>
          </a:xfrm>
          <a:custGeom>
            <a:avLst/>
            <a:gdLst>
              <a:gd name="textAreaLeft" fmla="*/ 13320 w 100080"/>
              <a:gd name="textAreaRight" fmla="*/ 86760 w 100080"/>
              <a:gd name="textAreaTop" fmla="*/ 21240 h 120600"/>
              <a:gd name="textAreaBottom" fmla="*/ 84240 h 120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7655" stAng="-5400000" swAng="5400000"/>
                <a:lnTo>
                  <a:pt x="21600" y="11230"/>
                </a:lnTo>
                <a:arcTo wR="21600" hR="7655" stAng="0" swAng="3772934"/>
                <a:lnTo>
                  <a:pt x="3857" y="21477"/>
                </a:lnTo>
                <a:lnTo>
                  <a:pt x="0" y="17097"/>
                </a:lnTo>
                <a:lnTo>
                  <a:pt x="3857" y="12470"/>
                </a:lnTo>
                <a:lnTo>
                  <a:pt x="3857" y="15186"/>
                </a:lnTo>
                <a:arcTo wR="21600" hR="7655" stAng="3772934" swAng="-3481058"/>
                <a:lnTo>
                  <a:pt x="21003" y="9442"/>
                </a:lnTo>
                <a:arcTo wR="21600" hR="7655" stAng="-291876" swAng="-5108124"/>
                <a:close/>
              </a:path>
              <a:path fill="darkenLess" w="21600" h="21600">
                <a:moveTo>
                  <a:pt x="0" y="0"/>
                </a:moveTo>
                <a:arcTo wR="21600" hR="7655" stAng="-5400000" swAng="5400000"/>
                <a:lnTo>
                  <a:pt x="21600" y="11230"/>
                </a:lnTo>
                <a:arcTo wR="21600" hR="7655" stAng="0" swAng="-291876"/>
                <a:lnTo>
                  <a:pt x="21003" y="9442"/>
                </a:lnTo>
                <a:arcTo wR="21600" hR="7655" stAng="-291876" swAng="-5108124"/>
                <a:close/>
              </a:path>
            </a:pathLst>
          </a:custGeom>
          <a:solidFill>
            <a:srgbClr val="0000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6200" bIns="162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sp>
        <p:nvSpPr>
          <p:cNvPr id="84" name="小サイクロン左"/>
          <p:cNvSpPr/>
          <p:nvPr/>
        </p:nvSpPr>
        <p:spPr>
          <a:xfrm flipH="1" flipV="1">
            <a:off x="4757040" y="2890080"/>
            <a:ext cx="90360" cy="82440"/>
          </a:xfrm>
          <a:custGeom>
            <a:avLst/>
            <a:gdLst>
              <a:gd name="textAreaLeft" fmla="*/ 11880 w 90360"/>
              <a:gd name="textAreaRight" fmla="*/ 78480 w 90360"/>
              <a:gd name="textAreaTop" fmla="*/ 12240 h 82440"/>
              <a:gd name="textAreaBottom" fmla="*/ 59040 h 82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5400000"/>
                <a:lnTo>
                  <a:pt x="0" y="21600"/>
                </a:lnTo>
                <a:lnTo>
                  <a:pt x="0" y="16200"/>
                </a:lnTo>
                <a:lnTo>
                  <a:pt x="0" y="10800"/>
                </a:lnTo>
                <a:lnTo>
                  <a:pt x="0" y="13500"/>
                </a:lnTo>
                <a:arcTo wR="21600" hR="6750" stAng="5400000" swAng="-4934014"/>
                <a:lnTo>
                  <a:pt x="19797" y="9450"/>
                </a:lnTo>
                <a:arcTo wR="21600" hR="6750" stAng="-465986" swAng="-4934014"/>
                <a:close/>
              </a:path>
              <a:path fill="darkenLess" w="21600" h="21600">
                <a:moveTo>
                  <a:pt x="0" y="0"/>
                </a:moveTo>
                <a:arcTo wR="21600" hR="6750" stAng="-5400000" swAng="5400000"/>
                <a:lnTo>
                  <a:pt x="21600" y="12150"/>
                </a:lnTo>
                <a:arcTo wR="21600" hR="6750" stAng="0" swAng="-465986"/>
                <a:lnTo>
                  <a:pt x="19797" y="9450"/>
                </a:lnTo>
                <a:arcTo wR="21600" hR="6750" stAng="-465986" swAng="-4934014"/>
                <a:close/>
              </a:path>
            </a:pathLst>
          </a:custGeom>
          <a:solidFill>
            <a:srgbClr val="0000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Meiryo UI"/>
            </a:endParaRPr>
          </a:p>
        </p:txBody>
      </p:sp>
      <p:grpSp>
        <p:nvGrpSpPr>
          <p:cNvPr id="85" name="サイクロン微粉"/>
          <p:cNvGrpSpPr/>
          <p:nvPr/>
        </p:nvGrpSpPr>
        <p:grpSpPr>
          <a:xfrm>
            <a:off x="4716360" y="2776680"/>
            <a:ext cx="265320" cy="171360"/>
            <a:chOff x="4716360" y="2776680"/>
            <a:chExt cx="265320" cy="171360"/>
          </a:xfrm>
        </p:grpSpPr>
        <p:sp>
          <p:nvSpPr>
            <p:cNvPr id="86" name="円/楕円 61"/>
            <p:cNvSpPr/>
            <p:nvPr/>
          </p:nvSpPr>
          <p:spPr>
            <a:xfrm>
              <a:off x="4767480" y="280404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87" name="円/楕円 62"/>
            <p:cNvSpPr/>
            <p:nvPr/>
          </p:nvSpPr>
          <p:spPr>
            <a:xfrm>
              <a:off x="4822200" y="2776680"/>
              <a:ext cx="540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88" name="円/楕円 63"/>
            <p:cNvSpPr/>
            <p:nvPr/>
          </p:nvSpPr>
          <p:spPr>
            <a:xfrm>
              <a:off x="4864320" y="2790720"/>
              <a:ext cx="576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89" name="円/楕円 64"/>
            <p:cNvSpPr/>
            <p:nvPr/>
          </p:nvSpPr>
          <p:spPr>
            <a:xfrm>
              <a:off x="4924440" y="2780640"/>
              <a:ext cx="576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0" name="円/楕円 65"/>
            <p:cNvSpPr/>
            <p:nvPr/>
          </p:nvSpPr>
          <p:spPr>
            <a:xfrm>
              <a:off x="4959720" y="2853720"/>
              <a:ext cx="540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1" name="円/楕円 66"/>
            <p:cNvSpPr/>
            <p:nvPr/>
          </p:nvSpPr>
          <p:spPr>
            <a:xfrm>
              <a:off x="4723920" y="284148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2" name="円/楕円 67"/>
            <p:cNvSpPr/>
            <p:nvPr/>
          </p:nvSpPr>
          <p:spPr>
            <a:xfrm>
              <a:off x="4869000" y="2896560"/>
              <a:ext cx="540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3" name="円/楕円 68"/>
            <p:cNvSpPr/>
            <p:nvPr/>
          </p:nvSpPr>
          <p:spPr>
            <a:xfrm>
              <a:off x="4773240" y="2885400"/>
              <a:ext cx="540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4" name="円/楕円 69"/>
            <p:cNvSpPr/>
            <p:nvPr/>
          </p:nvSpPr>
          <p:spPr>
            <a:xfrm>
              <a:off x="4933800" y="2927880"/>
              <a:ext cx="540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5" name="円/楕円 70"/>
            <p:cNvSpPr/>
            <p:nvPr/>
          </p:nvSpPr>
          <p:spPr>
            <a:xfrm>
              <a:off x="4912920" y="2890440"/>
              <a:ext cx="576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6" name="円/楕円 71"/>
            <p:cNvSpPr/>
            <p:nvPr/>
          </p:nvSpPr>
          <p:spPr>
            <a:xfrm>
              <a:off x="4802760" y="292500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7" name="円/楕円 72"/>
            <p:cNvSpPr/>
            <p:nvPr/>
          </p:nvSpPr>
          <p:spPr>
            <a:xfrm>
              <a:off x="4729320" y="2936880"/>
              <a:ext cx="576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8" name="円/楕円 73"/>
            <p:cNvSpPr/>
            <p:nvPr/>
          </p:nvSpPr>
          <p:spPr>
            <a:xfrm>
              <a:off x="4821480" y="2837520"/>
              <a:ext cx="576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99" name="円/楕円 74"/>
            <p:cNvSpPr/>
            <p:nvPr/>
          </p:nvSpPr>
          <p:spPr>
            <a:xfrm>
              <a:off x="4716360" y="278064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0" name="円/楕円 75"/>
            <p:cNvSpPr/>
            <p:nvPr/>
          </p:nvSpPr>
          <p:spPr>
            <a:xfrm>
              <a:off x="4972680" y="2792880"/>
              <a:ext cx="5760" cy="1116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1" name="円/楕円 76"/>
            <p:cNvSpPr/>
            <p:nvPr/>
          </p:nvSpPr>
          <p:spPr>
            <a:xfrm>
              <a:off x="4976280" y="2925000"/>
              <a:ext cx="5400" cy="1188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</p:grpSp>
      <p:grpSp>
        <p:nvGrpSpPr>
          <p:cNvPr id="102" name="サイクロン粉"/>
          <p:cNvGrpSpPr/>
          <p:nvPr/>
        </p:nvGrpSpPr>
        <p:grpSpPr>
          <a:xfrm>
            <a:off x="4708440" y="2890800"/>
            <a:ext cx="271440" cy="219240"/>
            <a:chOff x="4708440" y="2890800"/>
            <a:chExt cx="271440" cy="219240"/>
          </a:xfrm>
        </p:grpSpPr>
        <p:sp>
          <p:nvSpPr>
            <p:cNvPr id="103" name="円/楕円 48"/>
            <p:cNvSpPr/>
            <p:nvPr/>
          </p:nvSpPr>
          <p:spPr>
            <a:xfrm flipH="1">
              <a:off x="4913280" y="2963160"/>
              <a:ext cx="21240" cy="2592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4" name="円/楕円 49"/>
            <p:cNvSpPr/>
            <p:nvPr/>
          </p:nvSpPr>
          <p:spPr>
            <a:xfrm flipH="1">
              <a:off x="4749120" y="2976480"/>
              <a:ext cx="21240" cy="2484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5" name="円/楕円 50"/>
            <p:cNvSpPr/>
            <p:nvPr/>
          </p:nvSpPr>
          <p:spPr>
            <a:xfrm flipH="1">
              <a:off x="4798440" y="2989080"/>
              <a:ext cx="22320" cy="2484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6" name="円/楕円 51"/>
            <p:cNvSpPr/>
            <p:nvPr/>
          </p:nvSpPr>
          <p:spPr>
            <a:xfrm flipH="1">
              <a:off x="4928760" y="3019680"/>
              <a:ext cx="22320" cy="2592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7" name="円/楕円 52"/>
            <p:cNvSpPr/>
            <p:nvPr/>
          </p:nvSpPr>
          <p:spPr>
            <a:xfrm flipH="1">
              <a:off x="4957560" y="2966400"/>
              <a:ext cx="22320" cy="2592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8" name="円/楕円 53"/>
            <p:cNvSpPr/>
            <p:nvPr/>
          </p:nvSpPr>
          <p:spPr>
            <a:xfrm flipH="1">
              <a:off x="4851000" y="2992320"/>
              <a:ext cx="22320" cy="2592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09" name="円/楕円 54"/>
            <p:cNvSpPr/>
            <p:nvPr/>
          </p:nvSpPr>
          <p:spPr>
            <a:xfrm flipH="1">
              <a:off x="4809240" y="3071880"/>
              <a:ext cx="22320" cy="2484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10" name="円/楕円 55"/>
            <p:cNvSpPr/>
            <p:nvPr/>
          </p:nvSpPr>
          <p:spPr>
            <a:xfrm flipH="1">
              <a:off x="4708440" y="2890800"/>
              <a:ext cx="22320" cy="2592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  <p:sp>
          <p:nvSpPr>
            <p:cNvPr id="111" name="円/楕円 57"/>
            <p:cNvSpPr/>
            <p:nvPr/>
          </p:nvSpPr>
          <p:spPr>
            <a:xfrm flipH="1">
              <a:off x="4904280" y="3084120"/>
              <a:ext cx="22320" cy="25920"/>
            </a:xfrm>
            <a:prstGeom prst="ellipse">
              <a:avLst/>
            </a:prstGeom>
            <a:solidFill>
              <a:srgbClr val="0000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Meiryo UI"/>
              </a:endParaRPr>
            </a:p>
          </p:txBody>
        </p:sp>
      </p:grpSp>
      <p:sp>
        <p:nvSpPr>
          <p:cNvPr id="112" name="テキスト ボックス 5"/>
          <p:cNvSpPr/>
          <p:nvPr/>
        </p:nvSpPr>
        <p:spPr>
          <a:xfrm>
            <a:off x="426960" y="4581360"/>
            <a:ext cx="8393040" cy="193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Meiryo UI"/>
              </a:rPr>
              <a:t>Additional file 1 figure S1</a:t>
            </a:r>
            <a:endParaRPr b="0" lang="en-US" sz="1100" spc="-1" strike="noStrike">
              <a:solidFill>
                <a:srgbClr val="000000"/>
              </a:solidFill>
              <a:latin typeface="Meiryo U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Meiryo UI"/>
              </a:rPr>
              <a:t>Blue arrows indicate the flow of the MWNT-7. Red arrows indicate aerosolization of the MWNT-7 by the upward spiraling airstream.</a:t>
            </a:r>
            <a:endParaRPr b="0" lang="en-US" sz="1100" spc="-1" strike="noStrike">
              <a:solidFill>
                <a:srgbClr val="000000"/>
              </a:solidFill>
              <a:latin typeface="Meiryo U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Meiryo UI"/>
              </a:rPr>
              <a:t>MWNT-7 (Bulk MWNT-7) is first placed into the dust feeder.</a:t>
            </a:r>
            <a:endParaRPr b="0" lang="en-US" sz="1100" spc="-1" strike="noStrike">
              <a:solidFill>
                <a:srgbClr val="000000"/>
              </a:solidFill>
              <a:latin typeface="Meiryo U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Meiryo UI"/>
              </a:rPr>
              <a:t>The dust feeder transports a portion of the MWNT-7 into the sieving chamber (Left panel).  In the sieving chamber, clean air is aspirated from 9 diagonally opened slits by using the ejector air as the driving force, so that an upward spiraling airstream is continuously generated in the cylindrical sieving chamber.  MWNT-7 is dispersed and aerosolized by the high-speed spiraling air. Light MWNT-7 particles are carried to the top of the sieving chamber, where a partitioning sieve is located.  Only the sieved MWNT-7 can be delivered to the inhalation chamber.</a:t>
            </a:r>
            <a:endParaRPr b="0" lang="en-US" sz="1100" spc="-1" strike="noStrike">
              <a:solidFill>
                <a:srgbClr val="000000"/>
              </a:solidFill>
              <a:latin typeface="Meiryo U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Meiryo UI"/>
              </a:rPr>
              <a:t>Ionizers are used to avoid agglomeration. </a:t>
            </a:r>
            <a:endParaRPr b="0" lang="en-US" sz="1100" spc="-1" strike="noStrike">
              <a:solidFill>
                <a:srgbClr val="000000"/>
              </a:solidFill>
              <a:latin typeface="Meiryo U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Meiryo UI"/>
              </a:rPr>
              <a:t>This equipment has a feedback system for keeping the aerosol concentration in the inhalation chamber constant.</a:t>
            </a:r>
            <a:r>
              <a:rPr b="0" lang="ja-JP" sz="1100" spc="-1" strike="noStrike">
                <a:solidFill>
                  <a:srgbClr val="000000"/>
                </a:solidFill>
                <a:latin typeface="Meiryo UI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Meiryo U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entr" presetID="2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7" dur="10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1000"/>
                            </p:stCondLst>
                            <p:childTnLst>
                              <p:par>
                                <p:cTn id="9" nodeType="afterEffect" fill="hold" presetClass="entr" presetID="2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11" dur="10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2000"/>
                            </p:stCondLst>
                            <p:childTnLst>
                              <p:par>
                                <p:cTn id="13" nodeType="afterEffect" fill="hold" presetClass="entr" presetID="2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15" dur="1000"/>
                                        <p:tgtEl>
                                          <p:spTgt spid="8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3000"/>
                            </p:stCondLst>
                            <p:childTnLst>
                              <p:par>
                                <p:cTn id="17" nodeType="afterEffect" fill="hold" presetClass="entr" presetID="2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19" dur="1000"/>
                                        <p:tgtEl>
                                          <p:spTgt spid="8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nodeType="withEffect" fill="hold" presetClass="entr" presetID="2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22" dur="1000"/>
                                        <p:tgtEl>
                                          <p:spTgt spid="10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nodeType="withEffect" fill="hold" presetClass="entr" presetID="2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25" dur="1000"/>
                                        <p:tgtEl>
                                          <p:spTgt spid="8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4000"/>
                            </p:stCondLst>
                            <p:childTnLst>
                              <p:par>
                                <p:cTn id="27" nodeType="afterEffect" fill="hold" presetClass="entr" presetID="2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29" dur="10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" fill="hold">
                            <p:stCondLst>
                              <p:cond delay="5000"/>
                            </p:stCondLst>
                            <p:childTnLst>
                              <p:par>
                                <p:cTn id="31" nodeType="afterEffect" fill="hold" presetClass="entr" presetID="22" presetSubtype="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33" dur="10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" fill="hold">
                            <p:stCondLst>
                              <p:cond delay="6000"/>
                            </p:stCondLst>
                            <p:childTnLst>
                              <p:par>
                                <p:cTn id="35" nodeType="afterEffect" fill="hold" presetClass="entr" presetID="2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37" dur="2000"/>
                                        <p:tgtEl>
                                          <p:spTgt spid="5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8000"/>
                            </p:stCondLst>
                            <p:childTnLst>
                              <p:par>
                                <p:cTn id="39" nodeType="afterEffect" fill="hold" presetClass="entr" presetID="2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41" dur="700"/>
                                        <p:tgtEl>
                                          <p:spTgt spid="7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" nodeType="withEffect" fill="hold" presetClass="entr" presetID="22" presetSubtype="4">
                                  <p:stCondLst>
                                    <p:cond delay="70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44" dur="700"/>
                                        <p:tgtEl>
                                          <p:spTgt spid="7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5" nodeType="withEffect" fill="hold" presetClass="entr" presetID="22" presetSubtype="1">
                                  <p:stCondLst>
                                    <p:cond delay="120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47" dur="700"/>
                                        <p:tgtEl>
                                          <p:spTgt spid="7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8" nodeType="withEffect" fill="hold" presetClass="entr" presetID="22" presetSubtype="4">
                                  <p:stCondLst>
                                    <p:cond delay="190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50" dur="700"/>
                                        <p:tgtEl>
                                          <p:spTgt spid="7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1" nodeType="withEffect" fill="hold" presetClass="entr" presetID="22" presetSubtype="1">
                                  <p:stCondLst>
                                    <p:cond delay="240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53" dur="700"/>
                                        <p:tgtEl>
                                          <p:spTgt spid="7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4" nodeType="withEffect" fill="hold" presetClass="entr" presetID="22" presetSubtype="4">
                                  <p:stCondLst>
                                    <p:cond delay="310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56" dur="500"/>
                                        <p:tgtEl>
                                          <p:spTgt spid="7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7" nodeType="withEffect" fill="hold" presetClass="entr" presetID="22" presetSubtype="1">
                                  <p:stCondLst>
                                    <p:cond delay="340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59" dur="500"/>
                                        <p:tgtEl>
                                          <p:spTgt spid="7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0" nodeType="withEffect" fill="hold" presetClass="entr" presetID="22" presetSubtype="4">
                                  <p:stCondLst>
                                    <p:cond delay="3900"/>
                                  </p:stCondLst>
                                  <p:childTnLst>
                                    <p:set>
                                      <p:cBhvr>
                                        <p:cTn id="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62" dur="500"/>
                                        <p:tgtEl>
                                          <p:spTgt spid="7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3" fill="hold">
                            <p:stCondLst>
                              <p:cond delay="12400"/>
                            </p:stCondLst>
                            <p:childTnLst>
                              <p:par>
                                <p:cTn id="64" nodeType="afterEffect" fill="hold" presetClass="entr" presetID="2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66" dur="500"/>
                                        <p:tgtEl>
                                          <p:spTgt spid="7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7" fill="hold">
                            <p:stCondLst>
                              <p:cond delay="12900"/>
                            </p:stCondLst>
                            <p:childTnLst>
                              <p:par>
                                <p:cTn id="68" nodeType="afterEffect" fill="hold" presetClass="entr" presetID="2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down)" transition="in">
                                      <p:cBhvr additive="repl">
                                        <p:cTn id="70" dur="500"/>
                                        <p:tgtEl>
                                          <p:spTgt spid="8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2T11:25:27Z</dcterms:created>
  <dc:creator>梅田 ゆみ</dc:creator>
  <dc:description/>
  <dc:language>en-US</dc:language>
  <cp:lastModifiedBy>笠井 辰也</cp:lastModifiedBy>
  <cp:lastPrinted>2015-06-26T04:50:08Z</cp:lastPrinted>
  <dcterms:modified xsi:type="dcterms:W3CDTF">2016-09-26T02:48:02Z</dcterms:modified>
  <cp:revision>884</cp:revision>
  <dc:subject/>
  <dc:title>MWCNTの13週間吸入暴露で誘発されたラットの呼吸器毒性</dc:title>
</cp:coreProperties>
</file>